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588" y="1056"/>
      </p:cViewPr>
      <p:guideLst>
        <p:guide orient="horz" pos="4150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178316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731327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474337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21257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54629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202806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655132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1153661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13107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631921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3758941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48EEE1-27D3-4F72-A36F-F6C11E408181}" type="datetimeFigureOut">
              <a:rPr lang="de-DE" smtClean="0"/>
              <a:pPr/>
              <a:t>17.04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B185F9-F7A7-4D39-B6D6-2FDF6625CDC3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="" xmlns:p14="http://schemas.microsoft.com/office/powerpoint/2010/main" val="2128916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512800" y="2771800"/>
            <a:ext cx="3708363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smtClean="0">
                <a:latin typeface="Arial" panose="020B0604020202020204" pitchFamily="34" charset="0"/>
                <a:cs typeface="Arial" panose="020B0604020202020204" pitchFamily="34" charset="0"/>
              </a:rPr>
              <a:t>Additional file 1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DH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release as a marker of cellular damage was evaluated in the serum of the respective animals. I/R resulted in a statistically significant increase of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DH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ctivity compared to the sham group (P&lt;0.05, One-sample T-test).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PC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ttenuated the I/R induced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DH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activity to levels that were not significantly different from the sham control group. No difference was found between I/R and I/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+RIPC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P&gt;0.05, Student’s T-test). I/R, ischemia/reperfusion;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PC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remote ischemic preconditioning; ns, not significant; *, P&lt;0.05.  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3" y="504280"/>
            <a:ext cx="4176713" cy="21955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="" xmlns:p14="http://schemas.microsoft.com/office/powerpoint/2010/main" val="4139909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Slide 1</vt:lpstr>
    </vt:vector>
  </TitlesOfParts>
  <Company>ITSG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ummitzsch, Lars</dc:creator>
  <cp:lastModifiedBy>0013358</cp:lastModifiedBy>
  <cp:revision>10</cp:revision>
  <dcterms:created xsi:type="dcterms:W3CDTF">2019-03-21T10:29:12Z</dcterms:created>
  <dcterms:modified xsi:type="dcterms:W3CDTF">2019-04-17T03:53:17Z</dcterms:modified>
</cp:coreProperties>
</file>